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4"/>
  </p:notesMasterIdLst>
  <p:sldIdLst>
    <p:sldId id="256" r:id="rId2"/>
    <p:sldId id="257" r:id="rId3"/>
  </p:sldIdLst>
  <p:sldSz cx="6858000" cy="12193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545"/>
    <p:restoredTop sz="96296"/>
  </p:normalViewPr>
  <p:slideViewPr>
    <p:cSldViewPr snapToGrid="0">
      <p:cViewPr>
        <p:scale>
          <a:sx n="116" d="100"/>
          <a:sy n="116" d="100"/>
        </p:scale>
        <p:origin x="3616" y="-1928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921B10-B65F-274E-AAAB-FA8FFCA01514}" type="datetimeFigureOut">
              <a:rPr kumimoji="1" lang="ja-JP" altLang="en-US" smtClean="0"/>
              <a:t>2023/7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BFC370-5C19-2340-AD0D-1B25C36CDB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69893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BFC370-5C19-2340-AD0D-1B25C36CDB5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824784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BFC370-5C19-2340-AD0D-1B25C36CDB51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14651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572"/>
            <a:ext cx="5829300" cy="4245175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4457"/>
            <a:ext cx="5143500" cy="294396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74E46-D9B8-5C4E-AD4D-E52B63F8DA26}" type="datetimeFigureOut">
              <a:rPr kumimoji="1" lang="ja-JP" altLang="en-US" smtClean="0"/>
              <a:t>2023/7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5C23E-D580-E348-A008-2E4A20A837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7936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74E46-D9B8-5C4E-AD4D-E52B63F8DA26}" type="datetimeFigureOut">
              <a:rPr kumimoji="1" lang="ja-JP" altLang="en-US" smtClean="0"/>
              <a:t>2023/7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5C23E-D580-E348-A008-2E4A20A837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58547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96"/>
            <a:ext cx="1478756" cy="10333502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96"/>
            <a:ext cx="4350544" cy="10333502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74E46-D9B8-5C4E-AD4D-E52B63F8DA26}" type="datetimeFigureOut">
              <a:rPr kumimoji="1" lang="ja-JP" altLang="en-US" smtClean="0"/>
              <a:t>2023/7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5C23E-D580-E348-A008-2E4A20A837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50382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74E46-D9B8-5C4E-AD4D-E52B63F8DA26}" type="datetimeFigureOut">
              <a:rPr kumimoji="1" lang="ja-JP" altLang="en-US" smtClean="0"/>
              <a:t>2023/7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5C23E-D580-E348-A008-2E4A20A837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6855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933"/>
            <a:ext cx="5915025" cy="507219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60111"/>
            <a:ext cx="5915025" cy="266734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74E46-D9B8-5C4E-AD4D-E52B63F8DA26}" type="datetimeFigureOut">
              <a:rPr kumimoji="1" lang="ja-JP" altLang="en-US" smtClean="0"/>
              <a:t>2023/7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5C23E-D580-E348-A008-2E4A20A837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93582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978"/>
            <a:ext cx="2914650" cy="773672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978"/>
            <a:ext cx="2914650" cy="773672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74E46-D9B8-5C4E-AD4D-E52B63F8DA26}" type="datetimeFigureOut">
              <a:rPr kumimoji="1" lang="ja-JP" altLang="en-US" smtClean="0"/>
              <a:t>2023/7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5C23E-D580-E348-A008-2E4A20A837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02805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99"/>
            <a:ext cx="5915025" cy="23568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9124"/>
            <a:ext cx="2901255" cy="146492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4047"/>
            <a:ext cx="2901255" cy="655123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9124"/>
            <a:ext cx="2915543" cy="146492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4047"/>
            <a:ext cx="2915543" cy="655123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74E46-D9B8-5C4E-AD4D-E52B63F8DA26}" type="datetimeFigureOut">
              <a:rPr kumimoji="1" lang="ja-JP" altLang="en-US" smtClean="0"/>
              <a:t>2023/7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5C23E-D580-E348-A008-2E4A20A837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05649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74E46-D9B8-5C4E-AD4D-E52B63F8DA26}" type="datetimeFigureOut">
              <a:rPr kumimoji="1" lang="ja-JP" altLang="en-US" smtClean="0"/>
              <a:t>2023/7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5C23E-D580-E348-A008-2E4A20A837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08566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74E46-D9B8-5C4E-AD4D-E52B63F8DA26}" type="datetimeFigureOut">
              <a:rPr kumimoji="1" lang="ja-JP" altLang="en-US" smtClean="0"/>
              <a:t>2023/7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5C23E-D580-E348-A008-2E4A20A837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83763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906"/>
            <a:ext cx="2211884" cy="28451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653"/>
            <a:ext cx="3471863" cy="86653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8076"/>
            <a:ext cx="2211884" cy="6777039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74E46-D9B8-5C4E-AD4D-E52B63F8DA26}" type="datetimeFigureOut">
              <a:rPr kumimoji="1" lang="ja-JP" altLang="en-US" smtClean="0"/>
              <a:t>2023/7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5C23E-D580-E348-A008-2E4A20A837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11271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906"/>
            <a:ext cx="2211884" cy="28451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653"/>
            <a:ext cx="3471863" cy="866535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8076"/>
            <a:ext cx="2211884" cy="6777039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74E46-D9B8-5C4E-AD4D-E52B63F8DA26}" type="datetimeFigureOut">
              <a:rPr kumimoji="1" lang="ja-JP" altLang="en-US" smtClean="0"/>
              <a:t>2023/7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5C23E-D580-E348-A008-2E4A20A837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7708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99"/>
            <a:ext cx="5915025" cy="23568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978"/>
            <a:ext cx="5915025" cy="773672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1652"/>
            <a:ext cx="1543050" cy="6491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E74E46-D9B8-5C4E-AD4D-E52B63F8DA26}" type="datetimeFigureOut">
              <a:rPr kumimoji="1" lang="ja-JP" altLang="en-US" smtClean="0"/>
              <a:t>2023/7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1652"/>
            <a:ext cx="2314575" cy="6491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1652"/>
            <a:ext cx="1543050" cy="6491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05C23E-D580-E348-A008-2E4A20A837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9822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0919D57-B272-859E-E772-66A1C62053D4}"/>
              </a:ext>
            </a:extLst>
          </p:cNvPr>
          <p:cNvSpPr txBox="1"/>
          <p:nvPr/>
        </p:nvSpPr>
        <p:spPr>
          <a:xfrm>
            <a:off x="488378" y="793454"/>
            <a:ext cx="45878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A</a:t>
            </a:r>
            <a:endParaRPr kumimoji="1" lang="ja-JP" altLang="en-US" sz="2000"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50E0FED-096D-3D5E-FE2B-30201AA9FB8E}"/>
              </a:ext>
            </a:extLst>
          </p:cNvPr>
          <p:cNvSpPr txBox="1"/>
          <p:nvPr/>
        </p:nvSpPr>
        <p:spPr>
          <a:xfrm>
            <a:off x="0" y="0"/>
            <a:ext cx="30456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Supplemental Figure1</a:t>
            </a:r>
            <a:endParaRPr kumimoji="1" lang="ja-JP" altLang="en-US" sz="2000"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571E8FF8-7011-7E60-353E-3AC02FCEAE5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6584" y="925592"/>
            <a:ext cx="4852219" cy="3665617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56F9DAD-C642-B814-9001-5F40C274EDD4}"/>
              </a:ext>
            </a:extLst>
          </p:cNvPr>
          <p:cNvSpPr txBox="1"/>
          <p:nvPr/>
        </p:nvSpPr>
        <p:spPr>
          <a:xfrm>
            <a:off x="235974" y="5116691"/>
            <a:ext cx="6622026" cy="38318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altLang="ja-JP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 Figure 1.</a:t>
            </a:r>
            <a:endParaRPr lang="ja-JP" altLang="ja-JP" sz="1600" kern="1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altLang="ja-JP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ssessment of Ang-2 levels in the VETC-positive tumors of HCC patients. There was significant difference in Ang-2 expression between the mTOR-positive and -negative groups (p = 0.037). </a:t>
            </a:r>
          </a:p>
          <a:p>
            <a:pPr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altLang="ja-JP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ng-2, angiopoietin-2; HCC, Hepatocellular carcinoma; mTOR, mechanistic target of rapamycin; VETC, vessels that encapsulate tumor clusters</a:t>
            </a:r>
          </a:p>
          <a:p>
            <a:pPr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endParaRPr lang="ja-JP" altLang="ja-JP" sz="1600" kern="1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43969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50E0FED-096D-3D5E-FE2B-30201AA9FB8E}"/>
              </a:ext>
            </a:extLst>
          </p:cNvPr>
          <p:cNvSpPr txBox="1"/>
          <p:nvPr/>
        </p:nvSpPr>
        <p:spPr>
          <a:xfrm>
            <a:off x="0" y="0"/>
            <a:ext cx="30456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Supplemental Figure2</a:t>
            </a:r>
            <a:endParaRPr kumimoji="1" lang="ja-JP" altLang="en-US" sz="2000"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B311DED-26F3-0373-D540-60393970C827}"/>
              </a:ext>
            </a:extLst>
          </p:cNvPr>
          <p:cNvSpPr txBox="1"/>
          <p:nvPr/>
        </p:nvSpPr>
        <p:spPr>
          <a:xfrm>
            <a:off x="3291840" y="368550"/>
            <a:ext cx="45878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B</a:t>
            </a:r>
            <a:endParaRPr kumimoji="1" lang="ja-JP" altLang="en-US" sz="2000"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F800459-783D-65AB-8030-46D9D183E108}"/>
              </a:ext>
            </a:extLst>
          </p:cNvPr>
          <p:cNvSpPr txBox="1"/>
          <p:nvPr/>
        </p:nvSpPr>
        <p:spPr>
          <a:xfrm>
            <a:off x="0" y="368550"/>
            <a:ext cx="45878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A</a:t>
            </a:r>
            <a:endParaRPr kumimoji="1" lang="ja-JP" altLang="en-US" sz="2000"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9A8BC6C3-093E-EE7F-522D-48CD75A2091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768660"/>
            <a:ext cx="3566160" cy="2694062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A34A807D-6DDE-610E-EC74-77810BDB560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91840" y="768660"/>
            <a:ext cx="3566160" cy="2694062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CA8AF6E1-9277-446A-2D9E-F5BC3C83425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84523" y="3545947"/>
            <a:ext cx="3888954" cy="2937917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58071C8-AC39-C615-3210-499836FB8BB5}"/>
              </a:ext>
            </a:extLst>
          </p:cNvPr>
          <p:cNvSpPr txBox="1"/>
          <p:nvPr/>
        </p:nvSpPr>
        <p:spPr>
          <a:xfrm>
            <a:off x="1255133" y="3545947"/>
            <a:ext cx="45878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C</a:t>
            </a:r>
            <a:endParaRPr kumimoji="1" lang="ja-JP" altLang="en-US" sz="2000"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87D3B0C-F8BA-498D-DD38-D0F8D1DE84CC}"/>
              </a:ext>
            </a:extLst>
          </p:cNvPr>
          <p:cNvSpPr txBox="1"/>
          <p:nvPr/>
        </p:nvSpPr>
        <p:spPr>
          <a:xfrm>
            <a:off x="458780" y="6819440"/>
            <a:ext cx="5869236" cy="5022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altLang="ja-JP" sz="14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 Figure 2.</a:t>
            </a:r>
            <a:endParaRPr lang="ja-JP" altLang="ja-JP" sz="1400" kern="1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altLang="ja-JP" sz="14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: Kaplan-Meier analysis revealed that patients who could undergo surgery for recurrent HCC </a:t>
            </a:r>
            <a:endParaRPr lang="ja-JP" altLang="ja-JP" sz="1400" kern="1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altLang="ja-JP" sz="14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ad significantly better overall survival (OS) rates than inoperable patients; OS was measured from the time of HCC recurrence after LDLT.</a:t>
            </a:r>
            <a:endParaRPr lang="ja-JP" altLang="ja-JP" sz="1400" kern="1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altLang="ja-JP" sz="14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: Kaplan-Meier analysis revealed that the presence of VETC(+) recurrent lesions had no significant impact on prognosis pf patients who could undergo surgery for recurrent HCC. </a:t>
            </a:r>
            <a:endParaRPr lang="ja-JP" altLang="ja-JP" sz="1400" kern="1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altLang="ja-JP" sz="14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: Kaplan-Meier analysis revealed that the presence of VETC(+) primary lesions had no significant impact on prognosis pf patients who could not undergo surgery for recurrent HCC. </a:t>
            </a:r>
          </a:p>
          <a:p>
            <a:pPr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en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FS, disease-free survival; HCC, Hepatocellular carcinoma; OS, overall survival; VETC, vessels that encapsulate tumor clusters</a:t>
            </a:r>
            <a:endParaRPr lang="ja-JP" altLang="ja-JP" sz="1400" kern="1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39039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8</TotalTime>
  <Words>192</Words>
  <Application>Microsoft Macintosh PowerPoint</Application>
  <PresentationFormat>ユーザー設定</PresentationFormat>
  <Paragraphs>17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Microsoft Office User</cp:lastModifiedBy>
  <cp:revision>10</cp:revision>
  <cp:lastPrinted>2023-02-15T00:10:51Z</cp:lastPrinted>
  <dcterms:created xsi:type="dcterms:W3CDTF">2023-02-14T11:44:03Z</dcterms:created>
  <dcterms:modified xsi:type="dcterms:W3CDTF">2023-07-20T05:25:03Z</dcterms:modified>
</cp:coreProperties>
</file>